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8FD95-91EE-4F4C-BEE6-AD9440E239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DA210-0AB0-43F2-A8F2-703A3B0413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B13AE-12C5-42E1-A3D8-B84B63D3BE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5658D-6AC4-47A0-B656-DF8C6B5418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9DDBE-2656-402E-8A83-61DF2A1994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427801-428C-48BD-A365-9BECA6852F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CA66E-A4C0-4CD0-8A73-A468A543AE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D0A84-9164-4C74-B322-046F6686DD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31E4F-8108-4DE5-88D2-21D269E9E6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A39F6-8EC1-4208-8E55-F484D41915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B6416-F132-4A24-86D0-AA53DBEFD3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1A8A0-EF18-4A43-9780-6F5BC61A87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677B86-CD91-4A0D-B082-EF209014FA34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080" y="1773360"/>
          <a:ext cx="9091440" cy="2460600"/>
        </p:xfrm>
        <a:graphic>
          <a:graphicData uri="http://schemas.openxmlformats.org/drawingml/2006/table">
            <a:tbl>
              <a:tblPr/>
              <a:tblGrid>
                <a:gridCol w="1031760"/>
                <a:gridCol w="641520"/>
                <a:gridCol w="3240000"/>
                <a:gridCol w="2087640"/>
                <a:gridCol w="2090520"/>
              </a:tblGrid>
              <a:tr h="1778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cus 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ymb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ene 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sequence (5' - 3'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sequence (5' - 3'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60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1310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in, beta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CTTCCAGCCTTCCTTC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CGATCCAGACGGAGT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0010299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ldo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ldolase C, fructose-bisphosphate 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GCTATCAATAACTGCCG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CGGCCTCATTCTCTCTC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60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0010772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xo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khead box O1 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AGACCTCATGCCTTCA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CGCCCATGAGTTCGT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0010302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dl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 density lipoprotein recepto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AGAAAATGGCGTCAGAAAAAT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TCCTCTGTGGTCTTCTGATA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131183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r2f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clear receptor subfamily 2, group F, member 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AGTACGTTCGGAGCCAG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CTATGACCGAAGACGAGACT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640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M_70386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de4b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diesterase 4B, cAMP-specific 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CCCAGATAAGTGGAGT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TGCTGGTGTAGAAAGGA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00110256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para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roxisome proliferator-activated receptor alpha 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TTGTCGCTGCCATCATC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TGGAGAACGTTAACAA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60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M_0026675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pargc1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roxisome proliferator-activated receptor gamma, coactivator 1 alpha lik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TCAGTCCCAGTCGCA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TCATAGTCGCGTCGGTAC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1313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r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tinoic acid receptor, gamma 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AGAGGAGGATGACGATGAT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CTTTCTAGACACATCCGCG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452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0011051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rebf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erol regulatory element binding transcription factor 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GCAGACTCTCTACAGCTCCT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GGAGAGACTCGGAATTG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4520"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M_0010894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rebf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erol regulatory element binding transcription factor 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CTGCTGTTTCTGTCCTTTA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TCCTCCCTGCAGCGT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テキスト ボックス 3"/>
          <p:cNvSpPr/>
          <p:nvPr/>
        </p:nvSpPr>
        <p:spPr>
          <a:xfrm>
            <a:off x="52200" y="1227240"/>
            <a:ext cx="21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1. Primers for QP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2T03:47:59Z</dcterms:created>
  <dc:creator>Y. Shimada</dc:creator>
  <dc:description/>
  <dc:language>en-US</dc:language>
  <cp:lastModifiedBy>Y. Shimada</cp:lastModifiedBy>
  <dcterms:modified xsi:type="dcterms:W3CDTF">2011-12-02T03:26:35Z</dcterms:modified>
  <cp:revision>8</cp:revision>
  <dc:subject/>
  <dc:title>PowerPoint プレゼンテーション</dc:title>
</cp:coreProperties>
</file>